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7724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6197"/>
  </p:normalViewPr>
  <p:slideViewPr>
    <p:cSldViewPr snapToGrid="0" snapToObjects="1">
      <p:cViewPr varScale="1">
        <p:scale>
          <a:sx n="93" d="100"/>
          <a:sy n="93" d="100"/>
        </p:scale>
        <p:origin x="24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496484"/>
            <a:ext cx="6606540" cy="3183467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4802717"/>
            <a:ext cx="5829300" cy="2207683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964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377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486834"/>
            <a:ext cx="1675924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486834"/>
            <a:ext cx="4930616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488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696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279653"/>
            <a:ext cx="6703695" cy="3803649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119286"/>
            <a:ext cx="6703695" cy="2000249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013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659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486836"/>
            <a:ext cx="670369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241551"/>
            <a:ext cx="3288089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340100"/>
            <a:ext cx="328808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241551"/>
            <a:ext cx="3304282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340100"/>
            <a:ext cx="330428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161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56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393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316569"/>
            <a:ext cx="3934778" cy="6498167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28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316569"/>
            <a:ext cx="3934778" cy="6498167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006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486836"/>
            <a:ext cx="670369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434167"/>
            <a:ext cx="670369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D191D-78B0-034F-9797-47A76356133F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8475136"/>
            <a:ext cx="262318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8C58F5-A047-554A-903B-E4939643BA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252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>
            <a:extLst>
              <a:ext uri="{FF2B5EF4-FFF2-40B4-BE49-F238E27FC236}">
                <a16:creationId xmlns:a16="http://schemas.microsoft.com/office/drawing/2014/main" id="{BE10B395-9651-CD42-9300-BE58690EA928}"/>
              </a:ext>
            </a:extLst>
          </p:cNvPr>
          <p:cNvSpPr/>
          <p:nvPr/>
        </p:nvSpPr>
        <p:spPr>
          <a:xfrm>
            <a:off x="179262" y="5555436"/>
            <a:ext cx="7413873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Supplementary Figure 7. </a:t>
            </a:r>
            <a:r>
              <a:rPr lang="en-US" sz="1100" dirty="0"/>
              <a:t>(A-B) Longitudinal T1-post contrast MRI images showing tumor location at 3 weeks and 5 weeks post-</a:t>
            </a:r>
            <a:r>
              <a:rPr lang="en-US" sz="1100" dirty="0" err="1"/>
              <a:t>intrapontine</a:t>
            </a:r>
            <a:r>
              <a:rPr lang="en-US" sz="1100" dirty="0"/>
              <a:t> injection of 100K DF-1 cells. Blue arrowheads indicate primary tumor location within the pons tissue, red arrow heads indicate CSF space and lateral ventricle tumor dissemination. Scalebars = 5 mm. </a:t>
            </a:r>
            <a:endParaRPr lang="en-US" sz="1100" dirty="0">
              <a:effectLst/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C795AFDC-A202-6D40-B1E8-C6603761A0F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4547" b="28181"/>
          <a:stretch/>
        </p:blipFill>
        <p:spPr>
          <a:xfrm>
            <a:off x="353290" y="318417"/>
            <a:ext cx="7065818" cy="5237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1732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56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Shelei</dc:creator>
  <cp:lastModifiedBy>Pan, Shelei</cp:lastModifiedBy>
  <cp:revision>1</cp:revision>
  <dcterms:created xsi:type="dcterms:W3CDTF">2022-02-21T16:47:52Z</dcterms:created>
  <dcterms:modified xsi:type="dcterms:W3CDTF">2022-02-21T16:50:52Z</dcterms:modified>
</cp:coreProperties>
</file>